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8" r:id="rId3"/>
    <p:sldId id="257" r:id="rId4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979" y="37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5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5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5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5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5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5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5/1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5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5/1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5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5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4/5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32656" y="1691680"/>
            <a:ext cx="6192688" cy="517064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CTTTTTTTCAGTTTAATTCCTGAATTTATTTATATTTATTTATTTTACTATATGACATTTTCAAATATTTATTTTGTATACCTTTTATTAATCTTGATTAATTAAATGATAATGTAACAAACTAACACACTATCATGTTATTGATTAAGTGATGATGTGATAGACTAACAATGTCACGTTATCACTGATTTAGACTAATGGGTATAAAAATAAAAGTTTGAAAATATTAAATAATAAAATAAAATAAAACATTCAGCTTTTGACCAGATAAATGACAGATTATTGTTTGAAATAGAAAATATTGAAACATCAATATGAAAACGGGTGCAGGTAACACTTTTTTCAGTTCATTGTGCTGGGTGTCTGTATTACATGCTAGCTGATCGTTACCCCCACCAAGGAAAGACATGGATTGGAGCTGTGAATCCAAACTTCCGAGAGACAAGCCTTCGGATCAGATACATTTCAGCCATGTACTGGTCCATCACTACCATGACCACTGTAGGTTATGGTGACCTCCACGCTGTCAACACCATAGAAATGATCTTCATTATTTTCTACATGCTCTTTAACCTTGGCCTAACTGCTTACTTGATTGGTAACATGACAAATCTTGTTGTTGAAGGAACTCGCCGTACCATGGAGTTTAGAAATAGCATTGAAGCAGCATCAAATTTTGTGTGCCGAAATCGGTTGCCTCCAAGGTTAAAAGAGCAGATCTTGGCTTACATGTGCTTAAGATTTAAGGCAGAGAGCTTGAACCAGCATCAGCTTATTGAACAGCTTCCGAAGTCGATTTGCAAAAGCATCTGCCAGCATTTGTTTTTTGCAACTGTAGAGAAAGTCTATCTTTTCAAAGGCGTCTCAAAAGAAATTATTTTGTCCCTGGTTGCAAAAATGAAGGCAGAATACATACCACCCAGAGAGGATGTTATCATGCAAAATGAAGCACCAGATGATGTTTACATAATAGTCTCTGGCGAAGTGGAGATCCTCGATACTGAAACGGAGAAAGAAAGAATTTTAGGGACTCTACATACTGGGGAAATGTTTGGAGAGTTTGGTGCACTTTGTTGTAGACCTCAGAGCCTTACCTACAGAACCAAGACTCTCACACAGCTCCTGAGACTCAAGACCAATACTCTTCTAGAAGCAATGCAGATTAAAAGAGAAGATAACATACAAATACTCAAAAATTTTCTTCAGCATTTCAAGCAGGTTAAGGATCTGAGTATCAAAGATTTGATGGTGGAGAACGTAGAAGAAGAGGACCCTAACATGGCTGTGAACTTGCTAACTGTGGCAAGCACTGGCAATGCTGCTTTTCTTGAGGAGCTTCTAAGAGCAGGTTTGGATCCTGACATTGGAGACTCCAAAGGGAAAACTCCATTGCACATAGCAGCATCAAATGGGCATGAAGGGTGTGTTAAAGTCTTACTCAAGCATGCATGCAACATGCATATAAAAGACATGAATGGTAACACTGCACTATGGGATGCTATAGCATCAAAACATTACTCAATATTCCGGATCCTCTTCCAGCTTTCTGCTCTCTCTGATCCAAACATAGCAGGCGATCTCATGTGTACAGCAGCAAAAAGAAATGAACTAACAGTGATGACCGATCTTCTAAGGCAAGGACTAAACGTTGACTCCAAAGATCACCGTGATACAACTGCAATCCAAATTGCCATGGCCGAAAATCATGTTGACATGGTTCAGTTGCTTGTCATGAATGGTGCTGATGTCTCTGATGTGCATAACCATGAATTTTGTTCATCCACCTTAAATGAAATGCTGCAGAAGCGTGAAATTGGGCATCTAATTAATGTAACTGAGGTCATGCTCAGTGAAGTTGTATTAAAAGGGAGACATCAAGAGCAGGAGCACAATGGAGGAAGATCTAATAGTGGACTAAAGTTTCCAAGGGTAAGCATATATAGAGGTCACCCTGTAGTTAGAAGAGAAAAATGTTCCATGGAAGCTGGGAAGCTAATAAGGTTGCCTGATTCAATAGAGGAACTAAAAACTATTGCAGGTGAAAAATTTGGGTTTGATGCAAAAGATGCAATGGTGACAAATGAAGAAGGAGCTGAAATAGACTCCGTTGATGTGATCAGAGATAATGACAAACTTTTTTTTTGTTGGATAAGCTGAGATGCGAAAATGTCAAGTGTAAATATATATATAATCTCGCACAACAGATTTACTTAGATGTTTCTTT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836712" y="1266071"/>
            <a:ext cx="8199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Figure S1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32656" y="7236296"/>
            <a:ext cx="376309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eaLnBrk="0" hangingPunct="0"/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S1. 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Sequence of </a:t>
            </a:r>
            <a:r>
              <a:rPr lang="en-US" altLang="zh-CN" sz="1200" b="1" i="1" dirty="0" smtClean="0">
                <a:latin typeface="Times New Roman" pitchFamily="18" charset="0"/>
                <a:cs typeface="Times New Roman" pitchFamily="18" charset="0"/>
              </a:rPr>
              <a:t>GmAKT2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 full-length </a:t>
            </a:r>
            <a:r>
              <a:rPr lang="en-US" altLang="zh-CN" sz="1200" b="1" dirty="0" err="1" smtClean="0">
                <a:latin typeface="Times New Roman" pitchFamily="18" charset="0"/>
                <a:cs typeface="Times New Roman" pitchFamily="18" charset="0"/>
              </a:rPr>
              <a:t>cDNA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. </a:t>
            </a:r>
            <a:endParaRPr lang="en-US" altLang="zh-CN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48999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836712" y="1266071"/>
            <a:ext cx="8199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Figure S2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116632" y="4067944"/>
            <a:ext cx="669674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eaLnBrk="0" hangingPunct="0"/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S2. 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Amount 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of SMV RNA.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Ten-day-old soybean plants in low-K soil with unrolled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unifoliate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leaves were mechanically inoculated with SMV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G7, G3 or buffer (Mock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).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Soybean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trifoliate leaves were sampled at 14 and 28 DAI to extract total RNA for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-PCR analysis of SMV. Transcript levels were calculated using the formula 2</a:t>
            </a:r>
            <a:r>
              <a:rPr lang="en-US" altLang="zh-CN" sz="1200" baseline="30000" dirty="0">
                <a:latin typeface="Times New Roman" pitchFamily="18" charset="0"/>
                <a:cs typeface="Times New Roman" pitchFamily="18" charset="0"/>
              </a:rPr>
              <a:t>-ΔCt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for the expression levels relative to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GmACTIN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. Data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represent means of four biological replicates with error bars indicating SD. </a:t>
            </a:r>
          </a:p>
        </p:txBody>
      </p:sp>
      <p:pic>
        <p:nvPicPr>
          <p:cNvPr id="4" name="Picture 2" descr="C:\Documents and Settings\Administrator\桌面\图片1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88840" y="1907704"/>
            <a:ext cx="2524125" cy="19256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8947271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Documents and Settings\Administrator\桌面\图片13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44824" y="1694728"/>
            <a:ext cx="2880000" cy="23012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836712" y="1334688"/>
            <a:ext cx="8199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S3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139502" y="4127004"/>
            <a:ext cx="669674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S3. 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Phylogenetic analysis of soybean and </a:t>
            </a:r>
            <a:r>
              <a:rPr lang="en-US" altLang="zh-CN" sz="1200" b="1" i="1" dirty="0">
                <a:latin typeface="Times New Roman" pitchFamily="18" charset="0"/>
                <a:cs typeface="Times New Roman" pitchFamily="18" charset="0"/>
              </a:rPr>
              <a:t>Arabidopsis Shaker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 family proteins.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This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tree was obtained using the whole alignment and distance method. GmAKT2 and AtAKT2 formed a separate branch. The bar indicates the mean distance of 0.1 changes per amino acid residue.</a:t>
            </a:r>
            <a:endParaRPr lang="zh-CN" altLang="zh-CN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64899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3</TotalTime>
  <Words>143</Words>
  <Application>Microsoft Office PowerPoint</Application>
  <PresentationFormat>全屏显示(4:3)</PresentationFormat>
  <Paragraphs>7</Paragraphs>
  <Slides>3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cp:lastModifiedBy>admin</cp:lastModifiedBy>
  <cp:revision>34</cp:revision>
  <dcterms:modified xsi:type="dcterms:W3CDTF">2014-05-13T11:49:21Z</dcterms:modified>
</cp:coreProperties>
</file>